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138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73577F-41DE-69A6-ECF5-16B330FCF2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FC9E8A7-EB7C-A61F-C90F-77A7DF8A22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FEAD9B-DF72-7F86-80C0-924651EEA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BBF953-0B0E-803E-11F6-6A18260A1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2BC41F-5D9D-1C50-A339-0A7D735C9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4662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8C02CD-2F99-74EF-33BF-FD8466F41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7BEFA22-88A2-3F31-7AC3-DC9F549E9E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288A670-B982-084C-AEBF-BF0E48C2A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D41FC4C-8872-3FA6-AD73-49C85C228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CABD63-73EB-C879-A098-DF0209F89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1672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3FA7861-2A4C-5795-DD1F-D71B6C1F8D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182C202-E9D8-8151-C628-D6E861C45A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C70F87-8D19-D759-9833-CA785FF0D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6D74CA-D785-624A-62B1-E46145C15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F980395-5859-B444-F8EE-2036418D0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305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AA7DBB5-55CC-0B03-514F-CC893EB77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AA2C48C-084C-2D32-F9FE-A924A5A53A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ED525E-2310-CE4F-999F-F67E9EDDF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2B2517-595B-29E7-A263-987A4B2A6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668861-4083-C43C-D855-04A736A00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9697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CDB91A-224C-BA0D-24F4-3ADBCE1E89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080A6C0-6D88-E7B5-51C7-CF8BBEF9F1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E0AD95-A72F-ED46-DA0F-A85327CAE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3A4546-1002-AC27-B396-87B679BCB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81E785-240B-22D1-AE1E-75EA5BFE3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3299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54BE40-0ABB-B07D-B280-E4747BF44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B2AC27-6AC4-FF80-4FCD-9D6E6F8930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1D72234-091B-83F8-FBDF-BFBF327394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F5DD1C-772F-6E61-F510-A46B88942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C26B612-1FB5-43B9-39DE-99585D914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BA84FE3-9232-3FA8-4EC3-5A0D2A277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7292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041EAB-CDA1-0C1F-2A8F-D8201DBEB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02E37D-6E81-2085-0EB6-39B936B0E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C244124-CEF7-912C-E970-1B3EBF6097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73A295-5D52-8865-8028-7DF57EF254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5D29E3A-83D7-F755-9DBF-B869878F3A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58C4D46-F25E-6A4F-C2EE-AC34626D9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654AFEE-8557-05D6-FFB1-66283BBBC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3E3C285-C76D-A961-392D-6A22ADC04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910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5EDB47-AECC-DA5C-914B-5B5C60167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2ED451F-6644-4A96-67F3-4D411CA37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00B7230-C800-4A54-0A78-5789C1DC7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8428E84-B374-36B2-128F-CA7BBF766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8768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F756C71-6D71-3813-16B3-E06F785AD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5800025-91ED-F011-7FE4-24147D0D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DF74C0B-4C7D-9E12-E8C5-17676151D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2002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F32D676-040E-8CA4-0694-A1FEF3634A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DA9F95A-1F2A-6D2C-0751-C4418A7F4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60D419E-BE77-67AF-08B0-F05AC297CB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5CD2676-7673-7D6A-113C-B08D65A27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FDFFAB-A2CE-2EC2-F86B-32D58E921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7F6B508-0887-80E3-346B-95353F60E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4563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8FD450D-BAEB-F571-26C7-FD989D81A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32C94A1-0E36-2E1F-02DE-BDFC2B1A1D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4186923-0034-B204-F153-5E7812B9CE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8119CBC-327B-A2D9-1FFB-05A4DF04F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E63504C-3E12-AE37-5480-399440402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4921D35-8834-9C28-2471-C3E5F1BBE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2100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14DCA0F-0A78-4272-38C0-FE664A084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EE27CCB-B2FB-1BED-272F-8C213FE5A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C4C1DF2-0C16-130C-2193-9DAE2B744E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861794-5189-4FEE-96C1-F9C6A4F3C6D1}" type="datetimeFigureOut">
              <a:rPr lang="fr-FR" smtClean="0"/>
              <a:t>21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1FFD5D3-DC8A-CF8B-3926-0D98DC8941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F2E4179-C2CA-A874-466C-C3B67BAF04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CF43BF-B842-4C10-8062-EBF6415454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1666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712" y="1522115"/>
            <a:ext cx="5124727" cy="4018075"/>
          </a:xfrm>
          <a:prstGeom prst="rect">
            <a:avLst/>
          </a:prstGeom>
        </p:spPr>
      </p:pic>
      <p:sp>
        <p:nvSpPr>
          <p:cNvPr id="31" name="ZoneTexte 30">
            <a:extLst>
              <a:ext uri="{FF2B5EF4-FFF2-40B4-BE49-F238E27FC236}">
                <a16:creationId xmlns:a16="http://schemas.microsoft.com/office/drawing/2014/main" id="{4E6840DF-BF5A-CA1B-2E90-533DBA8E5B89}"/>
              </a:ext>
            </a:extLst>
          </p:cNvPr>
          <p:cNvSpPr txBox="1"/>
          <p:nvPr/>
        </p:nvSpPr>
        <p:spPr>
          <a:xfrm>
            <a:off x="-11286" y="1724253"/>
            <a:ext cx="400110" cy="327379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fr-FR" sz="1400" dirty="0"/>
              <a:t>Optimal </a:t>
            </a:r>
            <a:r>
              <a:rPr lang="fr-FR" sz="1400" dirty="0" err="1"/>
              <a:t>antibiotic</a:t>
            </a:r>
            <a:r>
              <a:rPr lang="fr-FR" sz="1400" dirty="0"/>
              <a:t> </a:t>
            </a:r>
            <a:r>
              <a:rPr lang="fr-FR" sz="1400" dirty="0" err="1" smtClean="0"/>
              <a:t>therapy</a:t>
            </a:r>
            <a:r>
              <a:rPr lang="fr-FR" sz="1400" dirty="0" smtClean="0"/>
              <a:t>(%)</a:t>
            </a:r>
            <a:endParaRPr lang="fr-FR" sz="1400" dirty="0"/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F0AFD6C1-A88A-93AE-470B-268C0DBD1F05}"/>
              </a:ext>
            </a:extLst>
          </p:cNvPr>
          <p:cNvSpPr txBox="1"/>
          <p:nvPr/>
        </p:nvSpPr>
        <p:spPr>
          <a:xfrm>
            <a:off x="2303302" y="5540190"/>
            <a:ext cx="1525132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fr-FR" sz="1400" dirty="0" smtClean="0"/>
              <a:t>Time(</a:t>
            </a:r>
            <a:r>
              <a:rPr lang="fr-FR" sz="1400" dirty="0" err="1" smtClean="0"/>
              <a:t>hours</a:t>
            </a:r>
            <a:r>
              <a:rPr lang="fr-FR" sz="1400" dirty="0"/>
              <a:t>)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AEF3E691-E6A0-BB9B-5D07-ACE8E0777BE2}"/>
              </a:ext>
            </a:extLst>
          </p:cNvPr>
          <p:cNvSpPr txBox="1"/>
          <p:nvPr/>
        </p:nvSpPr>
        <p:spPr>
          <a:xfrm>
            <a:off x="4215433" y="1632899"/>
            <a:ext cx="936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/>
              <a:t>P</a:t>
            </a:r>
            <a:r>
              <a:rPr lang="fr-FR" sz="1400" dirty="0" smtClean="0"/>
              <a:t>=0.102</a:t>
            </a:r>
            <a:endParaRPr lang="fr-FR" sz="1400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F34915B4-7A13-8B0F-E484-BB560F1082AE}"/>
              </a:ext>
            </a:extLst>
          </p:cNvPr>
          <p:cNvSpPr txBox="1"/>
          <p:nvPr/>
        </p:nvSpPr>
        <p:spPr>
          <a:xfrm>
            <a:off x="6602098" y="1724253"/>
            <a:ext cx="400110" cy="336031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fr-FR" sz="1400" dirty="0"/>
              <a:t>Optimal </a:t>
            </a:r>
            <a:r>
              <a:rPr lang="fr-FR" sz="1400" dirty="0" err="1"/>
              <a:t>antibiotic</a:t>
            </a:r>
            <a:r>
              <a:rPr lang="fr-FR" sz="1400" dirty="0"/>
              <a:t> </a:t>
            </a:r>
            <a:r>
              <a:rPr lang="fr-FR" sz="1400" dirty="0" err="1"/>
              <a:t>therapy</a:t>
            </a:r>
            <a:r>
              <a:rPr lang="fr-FR" sz="1400" dirty="0"/>
              <a:t> (%)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6F99A6FA-3D78-951F-6C48-B3781BCB14D4}"/>
              </a:ext>
            </a:extLst>
          </p:cNvPr>
          <p:cNvSpPr txBox="1"/>
          <p:nvPr/>
        </p:nvSpPr>
        <p:spPr>
          <a:xfrm>
            <a:off x="8982025" y="5540190"/>
            <a:ext cx="1466017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fr-FR" sz="1400" dirty="0" smtClean="0"/>
              <a:t>Time(</a:t>
            </a:r>
            <a:r>
              <a:rPr lang="fr-FR" sz="1400" dirty="0" err="1" smtClean="0"/>
              <a:t>hours</a:t>
            </a:r>
            <a:r>
              <a:rPr lang="fr-FR" sz="1400" dirty="0"/>
              <a:t>)</a:t>
            </a:r>
          </a:p>
        </p:txBody>
      </p:sp>
      <p:grpSp>
        <p:nvGrpSpPr>
          <p:cNvPr id="65" name="Groupe 64">
            <a:extLst>
              <a:ext uri="{FF2B5EF4-FFF2-40B4-BE49-F238E27FC236}">
                <a16:creationId xmlns:a16="http://schemas.microsoft.com/office/drawing/2014/main" id="{4054D495-CE41-7618-BE13-64C70558415E}"/>
              </a:ext>
            </a:extLst>
          </p:cNvPr>
          <p:cNvGrpSpPr/>
          <p:nvPr/>
        </p:nvGrpSpPr>
        <p:grpSpPr>
          <a:xfrm>
            <a:off x="3476090" y="4602693"/>
            <a:ext cx="1478685" cy="659373"/>
            <a:chOff x="4678865" y="2726787"/>
            <a:chExt cx="1478685" cy="659373"/>
          </a:xfrm>
        </p:grpSpPr>
        <p:sp>
          <p:nvSpPr>
            <p:cNvPr id="55" name="ZoneTexte 11">
              <a:extLst>
                <a:ext uri="{FF2B5EF4-FFF2-40B4-BE49-F238E27FC236}">
                  <a16:creationId xmlns:a16="http://schemas.microsoft.com/office/drawing/2014/main" id="{3D278070-8403-C27D-F71E-B2715F70F07A}"/>
                </a:ext>
              </a:extLst>
            </p:cNvPr>
            <p:cNvSpPr txBox="1"/>
            <p:nvPr/>
          </p:nvSpPr>
          <p:spPr>
            <a:xfrm>
              <a:off x="4906951" y="2726787"/>
              <a:ext cx="6767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400" dirty="0" err="1"/>
                <a:t>mPCR</a:t>
              </a:r>
              <a:endParaRPr lang="fr-FR" sz="1400" dirty="0"/>
            </a:p>
          </p:txBody>
        </p:sp>
        <p:sp>
          <p:nvSpPr>
            <p:cNvPr id="56" name="ZoneTexte 11">
              <a:extLst>
                <a:ext uri="{FF2B5EF4-FFF2-40B4-BE49-F238E27FC236}">
                  <a16:creationId xmlns:a16="http://schemas.microsoft.com/office/drawing/2014/main" id="{7526E3CC-B6FC-3685-204A-9A652EC2E717}"/>
                </a:ext>
              </a:extLst>
            </p:cNvPr>
            <p:cNvSpPr txBox="1"/>
            <p:nvPr/>
          </p:nvSpPr>
          <p:spPr>
            <a:xfrm>
              <a:off x="4906951" y="3078383"/>
              <a:ext cx="12505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400" dirty="0"/>
                <a:t>Control group</a:t>
              </a:r>
            </a:p>
          </p:txBody>
        </p:sp>
        <p:cxnSp>
          <p:nvCxnSpPr>
            <p:cNvPr id="58" name="Connecteur droit 57">
              <a:extLst>
                <a:ext uri="{FF2B5EF4-FFF2-40B4-BE49-F238E27FC236}">
                  <a16:creationId xmlns:a16="http://schemas.microsoft.com/office/drawing/2014/main" id="{4B203EFC-10F5-E731-B71F-7DC364E914CF}"/>
                </a:ext>
              </a:extLst>
            </p:cNvPr>
            <p:cNvCxnSpPr>
              <a:cxnSpLocks/>
              <a:endCxn id="55" idx="1"/>
            </p:cNvCxnSpPr>
            <p:nvPr/>
          </p:nvCxnSpPr>
          <p:spPr>
            <a:xfrm>
              <a:off x="4678865" y="2880676"/>
              <a:ext cx="2280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>
              <a:extLst>
                <a:ext uri="{FF2B5EF4-FFF2-40B4-BE49-F238E27FC236}">
                  <a16:creationId xmlns:a16="http://schemas.microsoft.com/office/drawing/2014/main" id="{8D972C2F-98E3-A024-7362-18D0CA735265}"/>
                </a:ext>
              </a:extLst>
            </p:cNvPr>
            <p:cNvCxnSpPr>
              <a:cxnSpLocks/>
              <a:endCxn id="56" idx="1"/>
            </p:cNvCxnSpPr>
            <p:nvPr/>
          </p:nvCxnSpPr>
          <p:spPr>
            <a:xfrm>
              <a:off x="4678865" y="3232272"/>
              <a:ext cx="228086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ZoneTexte 5">
            <a:extLst>
              <a:ext uri="{FF2B5EF4-FFF2-40B4-BE49-F238E27FC236}">
                <a16:creationId xmlns:a16="http://schemas.microsoft.com/office/drawing/2014/main" id="{36FBD4B8-C4A5-B5DE-1651-847824DBBACA}"/>
              </a:ext>
            </a:extLst>
          </p:cNvPr>
          <p:cNvSpPr txBox="1"/>
          <p:nvPr/>
        </p:nvSpPr>
        <p:spPr>
          <a:xfrm>
            <a:off x="1485352" y="936214"/>
            <a:ext cx="2849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u="sng" dirty="0"/>
              <a:t>Global </a:t>
            </a:r>
            <a:r>
              <a:rPr lang="fr-FR" sz="1400" b="1" u="sng" dirty="0" err="1"/>
              <a:t>cohort</a:t>
            </a:r>
            <a:r>
              <a:rPr lang="fr-FR" sz="1400" b="1" u="sng" dirty="0"/>
              <a:t>, n=95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9533B08F-997B-08A8-1B29-885DAA292DEF}"/>
              </a:ext>
            </a:extLst>
          </p:cNvPr>
          <p:cNvSpPr txBox="1"/>
          <p:nvPr/>
        </p:nvSpPr>
        <p:spPr>
          <a:xfrm>
            <a:off x="-6774" y="87465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94BBECC0-9CE7-801F-7632-580A129EC828}"/>
              </a:ext>
            </a:extLst>
          </p:cNvPr>
          <p:cNvSpPr txBox="1"/>
          <p:nvPr/>
        </p:nvSpPr>
        <p:spPr>
          <a:xfrm>
            <a:off x="6300164" y="936214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  <a:endParaRPr lang="fr-FR" b="1" dirty="0"/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7022A612-8217-65C4-D29D-ADBFF4245901}"/>
              </a:ext>
            </a:extLst>
          </p:cNvPr>
          <p:cNvSpPr txBox="1"/>
          <p:nvPr/>
        </p:nvSpPr>
        <p:spPr>
          <a:xfrm>
            <a:off x="7594881" y="936214"/>
            <a:ext cx="4240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u="sng" dirty="0"/>
              <a:t>First </a:t>
            </a:r>
            <a:r>
              <a:rPr lang="fr-FR" sz="1400" b="1" u="sng" dirty="0" err="1"/>
              <a:t>episode</a:t>
            </a:r>
            <a:r>
              <a:rPr lang="fr-FR" sz="1400" b="1" u="sng" dirty="0"/>
              <a:t> of </a:t>
            </a:r>
            <a:r>
              <a:rPr lang="fr-FR" sz="1400" b="1" u="sng" dirty="0" err="1"/>
              <a:t>pneumonia</a:t>
            </a:r>
            <a:r>
              <a:rPr lang="fr-FR" sz="1400" b="1" u="sng" dirty="0"/>
              <a:t>, n=59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02208" y="1522114"/>
            <a:ext cx="5013705" cy="4018075"/>
          </a:xfrm>
          <a:prstGeom prst="rect">
            <a:avLst/>
          </a:prstGeom>
        </p:spPr>
      </p:pic>
      <p:grpSp>
        <p:nvGrpSpPr>
          <p:cNvPr id="49" name="Groupe 48">
            <a:extLst>
              <a:ext uri="{FF2B5EF4-FFF2-40B4-BE49-F238E27FC236}">
                <a16:creationId xmlns:a16="http://schemas.microsoft.com/office/drawing/2014/main" id="{4054D495-CE41-7618-BE13-64C70558415E}"/>
              </a:ext>
            </a:extLst>
          </p:cNvPr>
          <p:cNvGrpSpPr/>
          <p:nvPr/>
        </p:nvGrpSpPr>
        <p:grpSpPr>
          <a:xfrm>
            <a:off x="10136866" y="4602693"/>
            <a:ext cx="1478685" cy="659373"/>
            <a:chOff x="4678865" y="2726787"/>
            <a:chExt cx="1478685" cy="659373"/>
          </a:xfrm>
        </p:grpSpPr>
        <p:sp>
          <p:nvSpPr>
            <p:cNvPr id="52" name="ZoneTexte 11">
              <a:extLst>
                <a:ext uri="{FF2B5EF4-FFF2-40B4-BE49-F238E27FC236}">
                  <a16:creationId xmlns:a16="http://schemas.microsoft.com/office/drawing/2014/main" id="{3D278070-8403-C27D-F71E-B2715F70F07A}"/>
                </a:ext>
              </a:extLst>
            </p:cNvPr>
            <p:cNvSpPr txBox="1"/>
            <p:nvPr/>
          </p:nvSpPr>
          <p:spPr>
            <a:xfrm>
              <a:off x="4906951" y="2726787"/>
              <a:ext cx="6767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400" dirty="0" err="1"/>
                <a:t>mPCR</a:t>
              </a:r>
              <a:endParaRPr lang="fr-FR" sz="1400" dirty="0"/>
            </a:p>
          </p:txBody>
        </p:sp>
        <p:sp>
          <p:nvSpPr>
            <p:cNvPr id="53" name="ZoneTexte 11">
              <a:extLst>
                <a:ext uri="{FF2B5EF4-FFF2-40B4-BE49-F238E27FC236}">
                  <a16:creationId xmlns:a16="http://schemas.microsoft.com/office/drawing/2014/main" id="{7526E3CC-B6FC-3685-204A-9A652EC2E717}"/>
                </a:ext>
              </a:extLst>
            </p:cNvPr>
            <p:cNvSpPr txBox="1"/>
            <p:nvPr/>
          </p:nvSpPr>
          <p:spPr>
            <a:xfrm>
              <a:off x="4906951" y="3078383"/>
              <a:ext cx="12505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400" dirty="0"/>
                <a:t>Control group</a:t>
              </a:r>
            </a:p>
          </p:txBody>
        </p:sp>
        <p:cxnSp>
          <p:nvCxnSpPr>
            <p:cNvPr id="57" name="Connecteur droit 56">
              <a:extLst>
                <a:ext uri="{FF2B5EF4-FFF2-40B4-BE49-F238E27FC236}">
                  <a16:creationId xmlns:a16="http://schemas.microsoft.com/office/drawing/2014/main" id="{4B203EFC-10F5-E731-B71F-7DC364E914CF}"/>
                </a:ext>
              </a:extLst>
            </p:cNvPr>
            <p:cNvCxnSpPr>
              <a:cxnSpLocks/>
              <a:endCxn id="52" idx="1"/>
            </p:cNvCxnSpPr>
            <p:nvPr/>
          </p:nvCxnSpPr>
          <p:spPr>
            <a:xfrm>
              <a:off x="4678865" y="2880676"/>
              <a:ext cx="2280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58">
              <a:extLst>
                <a:ext uri="{FF2B5EF4-FFF2-40B4-BE49-F238E27FC236}">
                  <a16:creationId xmlns:a16="http://schemas.microsoft.com/office/drawing/2014/main" id="{8D972C2F-98E3-A024-7362-18D0CA735265}"/>
                </a:ext>
              </a:extLst>
            </p:cNvPr>
            <p:cNvCxnSpPr>
              <a:cxnSpLocks/>
              <a:endCxn id="53" idx="1"/>
            </p:cNvCxnSpPr>
            <p:nvPr/>
          </p:nvCxnSpPr>
          <p:spPr>
            <a:xfrm>
              <a:off x="4678865" y="3232272"/>
              <a:ext cx="228086" cy="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ZoneTexte 59">
            <a:extLst>
              <a:ext uri="{FF2B5EF4-FFF2-40B4-BE49-F238E27FC236}">
                <a16:creationId xmlns:a16="http://schemas.microsoft.com/office/drawing/2014/main" id="{AEF3E691-E6A0-BB9B-5D07-ACE8E0777BE2}"/>
              </a:ext>
            </a:extLst>
          </p:cNvPr>
          <p:cNvSpPr txBox="1"/>
          <p:nvPr/>
        </p:nvSpPr>
        <p:spPr>
          <a:xfrm>
            <a:off x="10990251" y="1632899"/>
            <a:ext cx="936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/>
              <a:t>P</a:t>
            </a:r>
            <a:r>
              <a:rPr lang="fr-FR" sz="1400" dirty="0" smtClean="0"/>
              <a:t>=0.283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1899377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32</Words>
  <Application>Microsoft Office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BAY</dc:creator>
  <cp:lastModifiedBy>BAY Pierre</cp:lastModifiedBy>
  <cp:revision>12</cp:revision>
  <dcterms:created xsi:type="dcterms:W3CDTF">2024-02-21T19:17:46Z</dcterms:created>
  <dcterms:modified xsi:type="dcterms:W3CDTF">2024-03-21T14:14:25Z</dcterms:modified>
</cp:coreProperties>
</file>